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8" r:id="rId2"/>
  </p:sldIdLst>
  <p:sldSz cx="9144000" cy="6858000" type="screen4x3"/>
  <p:notesSz cx="6807200" cy="99393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63" autoAdjust="0"/>
    <p:restoredTop sz="91667" autoAdjust="0"/>
  </p:normalViewPr>
  <p:slideViewPr>
    <p:cSldViewPr showGuides="1">
      <p:cViewPr>
        <p:scale>
          <a:sx n="75" d="100"/>
          <a:sy n="75" d="100"/>
        </p:scale>
        <p:origin x="-72" y="90"/>
      </p:cViewPr>
      <p:guideLst>
        <p:guide orient="horz" pos="2160"/>
        <p:guide pos="2880"/>
      </p:guideLst>
    </p:cSldViewPr>
  </p:slideViewPr>
  <p:notesTextViewPr>
    <p:cViewPr>
      <p:scale>
        <a:sx n="50" d="100"/>
        <a:sy n="50" d="100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263" cy="496888"/>
          </a:xfrm>
          <a:prstGeom prst="rect">
            <a:avLst/>
          </a:prstGeom>
        </p:spPr>
        <p:txBody>
          <a:bodyPr vert="horz" lIns="91402" tIns="45701" rIns="91402" bIns="45701" rtlCol="0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5349" y="0"/>
            <a:ext cx="2950263" cy="496888"/>
          </a:xfrm>
          <a:prstGeom prst="rect">
            <a:avLst/>
          </a:prstGeom>
        </p:spPr>
        <p:txBody>
          <a:bodyPr vert="horz" lIns="91402" tIns="45701" rIns="91402" bIns="45701" rtlCol="0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CD03209F-71D4-48F2-A347-5D943B73B54E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7288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2" tIns="45701" rIns="91402" bIns="45701" rtlCol="0" anchor="ctr"/>
          <a:lstStyle/>
          <a:p>
            <a:pPr lvl="0"/>
            <a:endParaRPr lang="ja-JP" altLang="en-US" noProof="0" smtClean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1198" y="4721225"/>
            <a:ext cx="5444806" cy="4471988"/>
          </a:xfrm>
          <a:prstGeom prst="rect">
            <a:avLst/>
          </a:prstGeom>
        </p:spPr>
        <p:txBody>
          <a:bodyPr vert="horz" lIns="91402" tIns="45701" rIns="91402" bIns="45701" rtlCol="0">
            <a:normAutofit/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440864"/>
            <a:ext cx="2950263" cy="496887"/>
          </a:xfrm>
          <a:prstGeom prst="rect">
            <a:avLst/>
          </a:prstGeom>
        </p:spPr>
        <p:txBody>
          <a:bodyPr vert="horz" lIns="91402" tIns="45701" rIns="91402" bIns="45701" rtlCol="0" anchor="b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5349" y="9440864"/>
            <a:ext cx="2950263" cy="496887"/>
          </a:xfrm>
          <a:prstGeom prst="rect">
            <a:avLst/>
          </a:prstGeom>
        </p:spPr>
        <p:txBody>
          <a:bodyPr vert="horz" lIns="91402" tIns="45701" rIns="91402" bIns="45701" rtlCol="0" anchor="b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737BAAE5-1DD5-453F-A7F1-A35187F01D0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0621569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1EB22B-69B1-44EB-A5DF-0526783E2037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7B8E44-FC47-4D3B-ABC8-B5EF8093A44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F45C39-F940-4913-83C7-8169EA12A619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BF323-DF1D-4C73-AB62-3F5C8916697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03CEAF-8F26-4C78-A988-DE42CD959571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47349A-C0D8-4A2A-8A1D-ED12685851A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697C2C-BF4D-494D-BD10-4DB13BB2FF18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4FAC0A-4A48-4065-AF06-CAAEB9C04C8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151F2D-5305-47D1-8F21-C6630D5D1F48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384A1A-6099-40AB-9529-EB40014E336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0C21F1-520C-498C-84D5-F4B90FAFF8D6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3821F9-E3CD-4705-BDDC-1A8CE653633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386243-9E79-40C0-BAB8-A56376FE04B8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2E104E-F37E-4D88-8EDE-4E4476D592C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3A9952-21BC-4280-9AAC-F689181E4989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41E5CC-7C89-408C-801F-6B071E61E46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1610A4-64AB-4652-A47B-C74064707862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409C71-833E-4485-8CD2-2E45405E9E1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119BC3-7B66-49B4-B934-5E1A52765B47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5533A4-E1E9-4167-84DC-FD1261327E1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0A9625-A6AC-4482-B609-FFC15EE24069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C29261-A998-42A1-AE9D-E922A2FAE21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BA5F72C9-6909-43DD-87A2-1E313F56E8A1}" type="datetimeFigureOut">
              <a:rPr lang="ja-JP" altLang="en-US"/>
              <a:pPr>
                <a:defRPr/>
              </a:pPr>
              <a:t>2016/6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A6A64C53-806C-4457-9760-6D81E55E2D0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33"/>
          <p:cNvSpPr>
            <a:spLocks noChangeArrowheads="1"/>
          </p:cNvSpPr>
          <p:nvPr/>
        </p:nvSpPr>
        <p:spPr bwMode="auto">
          <a:xfrm>
            <a:off x="5680695" y="6309320"/>
            <a:ext cx="320703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 smtClean="0"/>
              <a:t>Suppl. Table 1</a:t>
            </a:r>
            <a:r>
              <a:rPr lang="en-US" altLang="ja-JP" dirty="0"/>
              <a:t>. </a:t>
            </a:r>
            <a:r>
              <a:rPr lang="en-US" altLang="ja-JP" dirty="0" smtClean="0"/>
              <a:t>Saito, </a:t>
            </a:r>
            <a:r>
              <a:rPr lang="en-US" altLang="ja-JP" dirty="0"/>
              <a:t>E</a:t>
            </a:r>
            <a:r>
              <a:rPr lang="en-US" altLang="ja-JP" dirty="0" smtClean="0"/>
              <a:t>. </a:t>
            </a:r>
            <a:r>
              <a:rPr lang="en-US" altLang="ja-JP" i="1" dirty="0"/>
              <a:t>et al.</a:t>
            </a:r>
          </a:p>
        </p:txBody>
      </p:sp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3050475"/>
              </p:ext>
            </p:extLst>
          </p:nvPr>
        </p:nvGraphicFramePr>
        <p:xfrm>
          <a:off x="1825585" y="2606505"/>
          <a:ext cx="5461000" cy="1594485"/>
        </p:xfrm>
        <a:graphic>
          <a:graphicData uri="http://schemas.openxmlformats.org/drawingml/2006/table">
            <a:tbl>
              <a:tblPr/>
              <a:tblGrid>
                <a:gridCol w="980505"/>
                <a:gridCol w="3287389"/>
                <a:gridCol w="1193106"/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targe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sequenc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 size (bp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f8 knockou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CATGGCACTGGTCCAGATGTCTTCC-3'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9 (wild-type)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7 (knockout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CTTCCAGGGGATACGGAACATGGTC-3'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CGAAGGAGCAAAGCTGCTATTGGCC-3'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f8-flox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TTGGGGATTTCCAGGCTGTTCTA-3'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 (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-typ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(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x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CACAGGGAGTCCCTCTTACAAT-3'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z2-c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CTTGGGCTGCCAGAATTTCTC-3' (common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(wild-type)</a:t>
                      </a:r>
                      <a:b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 (cre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TTACAGTCGGCCAGGCTGAC-3' (wild-type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CCCAGAAATGCCAGATTACG-3' (mutant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1F497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05964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96</TotalTime>
  <Words>78</Words>
  <Application>Microsoft Office PowerPoint</Application>
  <PresentationFormat>画面に合わせる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ser</dc:creator>
  <cp:lastModifiedBy>Dai Suzuki</cp:lastModifiedBy>
  <cp:revision>1254</cp:revision>
  <cp:lastPrinted>2016-05-26T10:20:10Z</cp:lastPrinted>
  <dcterms:created xsi:type="dcterms:W3CDTF">2008-04-14T12:06:24Z</dcterms:created>
  <dcterms:modified xsi:type="dcterms:W3CDTF">2016-06-14T07:01:36Z</dcterms:modified>
</cp:coreProperties>
</file>